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saveSubsetFonts="1" autoCompressPictures="0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390" r:id="rId2"/>
  </p:sldIdLst>
  <p:sldSz cx="15562263" cy="17546638"/>
  <p:notesSz cx="6858000" cy="9144000"/>
  <p:defaultTextStyle>
    <a:defPPr>
      <a:defRPr lang="en-US"/>
    </a:defPPr>
    <a:lvl1pPr marL="0" algn="l" defTabSz="1114379" rtl="0" eaLnBrk="1" latinLnBrk="0" hangingPunct="1">
      <a:defRPr sz="2194" kern="1200">
        <a:solidFill>
          <a:schemeClr val="tx1"/>
        </a:solidFill>
        <a:latin typeface="+mn-lt"/>
        <a:ea typeface="+mn-ea"/>
        <a:cs typeface="+mn-cs"/>
      </a:defRPr>
    </a:lvl1pPr>
    <a:lvl2pPr marL="557190" algn="l" defTabSz="1114379" rtl="0" eaLnBrk="1" latinLnBrk="0" hangingPunct="1">
      <a:defRPr sz="2194" kern="1200">
        <a:solidFill>
          <a:schemeClr val="tx1"/>
        </a:solidFill>
        <a:latin typeface="+mn-lt"/>
        <a:ea typeface="+mn-ea"/>
        <a:cs typeface="+mn-cs"/>
      </a:defRPr>
    </a:lvl2pPr>
    <a:lvl3pPr marL="1114379" algn="l" defTabSz="1114379" rtl="0" eaLnBrk="1" latinLnBrk="0" hangingPunct="1">
      <a:defRPr sz="2194" kern="1200">
        <a:solidFill>
          <a:schemeClr val="tx1"/>
        </a:solidFill>
        <a:latin typeface="+mn-lt"/>
        <a:ea typeface="+mn-ea"/>
        <a:cs typeface="+mn-cs"/>
      </a:defRPr>
    </a:lvl3pPr>
    <a:lvl4pPr marL="1671569" algn="l" defTabSz="1114379" rtl="0" eaLnBrk="1" latinLnBrk="0" hangingPunct="1">
      <a:defRPr sz="2194" kern="1200">
        <a:solidFill>
          <a:schemeClr val="tx1"/>
        </a:solidFill>
        <a:latin typeface="+mn-lt"/>
        <a:ea typeface="+mn-ea"/>
        <a:cs typeface="+mn-cs"/>
      </a:defRPr>
    </a:lvl4pPr>
    <a:lvl5pPr marL="2228759" algn="l" defTabSz="1114379" rtl="0" eaLnBrk="1" latinLnBrk="0" hangingPunct="1">
      <a:defRPr sz="2194" kern="1200">
        <a:solidFill>
          <a:schemeClr val="tx1"/>
        </a:solidFill>
        <a:latin typeface="+mn-lt"/>
        <a:ea typeface="+mn-ea"/>
        <a:cs typeface="+mn-cs"/>
      </a:defRPr>
    </a:lvl5pPr>
    <a:lvl6pPr marL="2785948" algn="l" defTabSz="1114379" rtl="0" eaLnBrk="1" latinLnBrk="0" hangingPunct="1">
      <a:defRPr sz="2194" kern="1200">
        <a:solidFill>
          <a:schemeClr val="tx1"/>
        </a:solidFill>
        <a:latin typeface="+mn-lt"/>
        <a:ea typeface="+mn-ea"/>
        <a:cs typeface="+mn-cs"/>
      </a:defRPr>
    </a:lvl6pPr>
    <a:lvl7pPr marL="3343138" algn="l" defTabSz="1114379" rtl="0" eaLnBrk="1" latinLnBrk="0" hangingPunct="1">
      <a:defRPr sz="2194" kern="1200">
        <a:solidFill>
          <a:schemeClr val="tx1"/>
        </a:solidFill>
        <a:latin typeface="+mn-lt"/>
        <a:ea typeface="+mn-ea"/>
        <a:cs typeface="+mn-cs"/>
      </a:defRPr>
    </a:lvl7pPr>
    <a:lvl8pPr marL="3900327" algn="l" defTabSz="1114379" rtl="0" eaLnBrk="1" latinLnBrk="0" hangingPunct="1">
      <a:defRPr sz="2194" kern="1200">
        <a:solidFill>
          <a:schemeClr val="tx1"/>
        </a:solidFill>
        <a:latin typeface="+mn-lt"/>
        <a:ea typeface="+mn-ea"/>
        <a:cs typeface="+mn-cs"/>
      </a:defRPr>
    </a:lvl8pPr>
    <a:lvl9pPr marL="4457517" algn="l" defTabSz="1114379" rtl="0" eaLnBrk="1" latinLnBrk="0" hangingPunct="1">
      <a:defRPr sz="2194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432FF"/>
    <a:srgbClr val="000000"/>
    <a:srgbClr val="FFFFFF"/>
    <a:srgbClr val="FF40FF"/>
    <a:srgbClr val="AC27A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B11EEEE-0304-4F4E-B53A-F212ECE370FC}" v="1" dt="2024-08-14T22:28:15.488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119"/>
    <p:restoredTop sz="95782"/>
  </p:normalViewPr>
  <p:slideViewPr>
    <p:cSldViewPr snapToGrid="0">
      <p:cViewPr varScale="1">
        <p:scale>
          <a:sx n="46" d="100"/>
          <a:sy n="46" d="100"/>
        </p:scale>
        <p:origin x="2880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>
      <p:cViewPr>
        <p:scale>
          <a:sx n="1" d="2"/>
          <a:sy n="1" d="2"/>
        </p:scale>
        <p:origin x="0" y="0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Relationship Id="rId9" Type="http://schemas.microsoft.com/office/2015/10/relationships/revisionInfo" Target="revisionInfo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>
            <a:extLst>
              <a:ext uri="{FF2B5EF4-FFF2-40B4-BE49-F238E27FC236}">
                <a16:creationId xmlns:a16="http://schemas.microsoft.com/office/drawing/2014/main" id="{2B1137E9-3125-C9DC-069E-2EFC7FD4E752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F8E7326-5A68-8CF5-B93F-4FAFF79AC1E2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1B62AE7-0510-7043-8514-23341998D747}" type="datetimeFigureOut">
              <a:rPr lang="en-US" smtClean="0"/>
              <a:t>8/20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53C3C2B-31C4-A7B8-7F9A-4B2F8EF1A33C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71B5F93-70EB-5C72-5813-7DFAB1A2F897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85B7DB3-4B09-6441-9E1D-2E54A81E2A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6855900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C525ECA-95A8-D54D-A55C-966C5ABDC60E}" type="datetimeFigureOut">
              <a:rPr lang="en-US" smtClean="0"/>
              <a:t>8/20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60575" y="1143000"/>
            <a:ext cx="27368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B202569-D9CA-7442-9875-62C29A14AB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5863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114379" rtl="0" eaLnBrk="1" latinLnBrk="0" hangingPunct="1">
      <a:defRPr sz="1462" kern="1200">
        <a:solidFill>
          <a:schemeClr val="tx1"/>
        </a:solidFill>
        <a:latin typeface="+mn-lt"/>
        <a:ea typeface="+mn-ea"/>
        <a:cs typeface="+mn-cs"/>
      </a:defRPr>
    </a:lvl1pPr>
    <a:lvl2pPr marL="557190" algn="l" defTabSz="1114379" rtl="0" eaLnBrk="1" latinLnBrk="0" hangingPunct="1">
      <a:defRPr sz="1462" kern="1200">
        <a:solidFill>
          <a:schemeClr val="tx1"/>
        </a:solidFill>
        <a:latin typeface="+mn-lt"/>
        <a:ea typeface="+mn-ea"/>
        <a:cs typeface="+mn-cs"/>
      </a:defRPr>
    </a:lvl2pPr>
    <a:lvl3pPr marL="1114379" algn="l" defTabSz="1114379" rtl="0" eaLnBrk="1" latinLnBrk="0" hangingPunct="1">
      <a:defRPr sz="1462" kern="1200">
        <a:solidFill>
          <a:schemeClr val="tx1"/>
        </a:solidFill>
        <a:latin typeface="+mn-lt"/>
        <a:ea typeface="+mn-ea"/>
        <a:cs typeface="+mn-cs"/>
      </a:defRPr>
    </a:lvl3pPr>
    <a:lvl4pPr marL="1671569" algn="l" defTabSz="1114379" rtl="0" eaLnBrk="1" latinLnBrk="0" hangingPunct="1">
      <a:defRPr sz="1462" kern="1200">
        <a:solidFill>
          <a:schemeClr val="tx1"/>
        </a:solidFill>
        <a:latin typeface="+mn-lt"/>
        <a:ea typeface="+mn-ea"/>
        <a:cs typeface="+mn-cs"/>
      </a:defRPr>
    </a:lvl4pPr>
    <a:lvl5pPr marL="2228759" algn="l" defTabSz="1114379" rtl="0" eaLnBrk="1" latinLnBrk="0" hangingPunct="1">
      <a:defRPr sz="1462" kern="1200">
        <a:solidFill>
          <a:schemeClr val="tx1"/>
        </a:solidFill>
        <a:latin typeface="+mn-lt"/>
        <a:ea typeface="+mn-ea"/>
        <a:cs typeface="+mn-cs"/>
      </a:defRPr>
    </a:lvl5pPr>
    <a:lvl6pPr marL="2785948" algn="l" defTabSz="1114379" rtl="0" eaLnBrk="1" latinLnBrk="0" hangingPunct="1">
      <a:defRPr sz="1462" kern="1200">
        <a:solidFill>
          <a:schemeClr val="tx1"/>
        </a:solidFill>
        <a:latin typeface="+mn-lt"/>
        <a:ea typeface="+mn-ea"/>
        <a:cs typeface="+mn-cs"/>
      </a:defRPr>
    </a:lvl6pPr>
    <a:lvl7pPr marL="3343138" algn="l" defTabSz="1114379" rtl="0" eaLnBrk="1" latinLnBrk="0" hangingPunct="1">
      <a:defRPr sz="1462" kern="1200">
        <a:solidFill>
          <a:schemeClr val="tx1"/>
        </a:solidFill>
        <a:latin typeface="+mn-lt"/>
        <a:ea typeface="+mn-ea"/>
        <a:cs typeface="+mn-cs"/>
      </a:defRPr>
    </a:lvl7pPr>
    <a:lvl8pPr marL="3900327" algn="l" defTabSz="1114379" rtl="0" eaLnBrk="1" latinLnBrk="0" hangingPunct="1">
      <a:defRPr sz="1462" kern="1200">
        <a:solidFill>
          <a:schemeClr val="tx1"/>
        </a:solidFill>
        <a:latin typeface="+mn-lt"/>
        <a:ea typeface="+mn-ea"/>
        <a:cs typeface="+mn-cs"/>
      </a:defRPr>
    </a:lvl8pPr>
    <a:lvl9pPr marL="4457517" algn="l" defTabSz="1114379" rtl="0" eaLnBrk="1" latinLnBrk="0" hangingPunct="1">
      <a:defRPr sz="1462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1114379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B202569-D9CA-7442-9875-62C29A14AB53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180658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6139EB-7257-7444-846C-A830F519A4F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945286" y="2871639"/>
            <a:ext cx="11671697" cy="6108831"/>
          </a:xfrm>
        </p:spPr>
        <p:txBody>
          <a:bodyPr anchor="b">
            <a:normAutofit/>
          </a:bodyPr>
          <a:lstStyle>
            <a:lvl1pPr algn="ctr">
              <a:defRPr sz="4679">
                <a:latin typeface="Helvetica" pitchFamily="2" charset="0"/>
                <a:cs typeface="Arial" panose="020B0604020202020204" pitchFamily="34" charset="0"/>
              </a:defRPr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1FF011D-5936-024D-894E-5D7272C02AE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945286" y="9216051"/>
            <a:ext cx="11671697" cy="4236375"/>
          </a:xfrm>
        </p:spPr>
        <p:txBody>
          <a:bodyPr/>
          <a:lstStyle>
            <a:lvl1pPr marL="0" indent="0" algn="ctr">
              <a:buNone/>
              <a:defRPr sz="2808">
                <a:latin typeface="Helvetica" pitchFamily="2" charset="0"/>
                <a:cs typeface="Arial" panose="020B0604020202020204" pitchFamily="34" charset="0"/>
              </a:defRPr>
            </a:lvl1pPr>
            <a:lvl2pPr marL="534800" indent="0" algn="ctr">
              <a:buNone/>
              <a:defRPr sz="2339"/>
            </a:lvl2pPr>
            <a:lvl3pPr marL="1069601" indent="0" algn="ctr">
              <a:buNone/>
              <a:defRPr sz="2105"/>
            </a:lvl3pPr>
            <a:lvl4pPr marL="1604400" indent="0" algn="ctr">
              <a:buNone/>
              <a:defRPr sz="1871"/>
            </a:lvl4pPr>
            <a:lvl5pPr marL="2139200" indent="0" algn="ctr">
              <a:buNone/>
              <a:defRPr sz="1871"/>
            </a:lvl5pPr>
            <a:lvl6pPr marL="2674001" indent="0" algn="ctr">
              <a:buNone/>
              <a:defRPr sz="1871"/>
            </a:lvl6pPr>
            <a:lvl7pPr marL="3208801" indent="0" algn="ctr">
              <a:buNone/>
              <a:defRPr sz="1871"/>
            </a:lvl7pPr>
            <a:lvl8pPr marL="3743601" indent="0" algn="ctr">
              <a:buNone/>
              <a:defRPr sz="1871"/>
            </a:lvl8pPr>
            <a:lvl9pPr marL="4278401" indent="0" algn="ctr">
              <a:buNone/>
              <a:defRPr sz="1871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0C64D72-5071-ED4A-AF12-75657B7500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Helvetica" pitchFamily="2" charset="0"/>
                <a:cs typeface="Arial" panose="020B0604020202020204" pitchFamily="34" charset="0"/>
              </a:defRPr>
            </a:lvl1pPr>
          </a:lstStyle>
          <a:p>
            <a:fld id="{1C9DEA9D-5532-1949-9D14-26A30D988B65}" type="datetime1">
              <a:rPr lang="en-US" smtClean="0"/>
              <a:t>8/2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B047D9-31F9-BC40-AB2B-EC56AF8F84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Helvetica" pitchFamily="2" charset="0"/>
                <a:cs typeface="Arial" panose="020B0604020202020204" pitchFamily="34" charset="0"/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16870F0-923B-0543-854F-D39BA67620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Helvetica" pitchFamily="2" charset="0"/>
                <a:cs typeface="Arial" panose="020B0604020202020204" pitchFamily="34" charset="0"/>
              </a:defRPr>
            </a:lvl1pPr>
          </a:lstStyle>
          <a:p>
            <a:fld id="{CE44A9E8-6FDC-F24D-B37B-1656C98EFDF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88170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B7044D-B51F-4546-8184-768D6ADE8E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D0F9904-7979-7F43-95DE-C5378709E90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59F89EC-86B5-C74C-AABB-DC26219348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91DBA4-200E-9843-B255-CEC4C6AAC196}" type="datetime1">
              <a:rPr lang="en-US" smtClean="0"/>
              <a:t>8/2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B863029-53B8-844B-B239-06CD1560A7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97F18CD-F8BD-C44A-8597-C2DB47E4D2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4A9E8-6FDC-F24D-B37B-1656C98EFD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14215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08C94FF-AADF-BF41-A28C-B3390397EB9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11136743" y="934196"/>
            <a:ext cx="3355614" cy="14869964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FFF3FEE-5F40-F248-B556-E00AA42CA18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1069908" y="934196"/>
            <a:ext cx="9872310" cy="14869964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FBDF995-7FA5-864D-AF3F-7D6AB7AE2D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AFD97-F89F-A042-BCAC-BC0C1F5BBEE5}" type="datetime1">
              <a:rPr lang="en-US" smtClean="0"/>
              <a:t>8/2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C0E0DB7-A73C-F146-A650-8078BA459C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9D75EA6-BF6F-744E-9873-479596026F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4A9E8-6FDC-F24D-B37B-1656C98EFD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05236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96BCAB-63B0-0B40-A1CD-6F636AE3D9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>
                <a:latin typeface="Helvetica" pitchFamily="2" charset="0"/>
              </a:defRPr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D73C1FF-5975-A24B-9612-9F4D8078EF0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>
            <a:lvl1pPr>
              <a:defRPr>
                <a:latin typeface="Helvetica" pitchFamily="2" charset="0"/>
              </a:defRPr>
            </a:lvl1pPr>
            <a:lvl2pPr>
              <a:defRPr>
                <a:latin typeface="Helvetica" pitchFamily="2" charset="0"/>
              </a:defRPr>
            </a:lvl2pPr>
            <a:lvl3pPr>
              <a:defRPr>
                <a:latin typeface="Helvetica" pitchFamily="2" charset="0"/>
              </a:defRPr>
            </a:lvl3pPr>
            <a:lvl4pPr>
              <a:defRPr>
                <a:latin typeface="Helvetica" pitchFamily="2" charset="0"/>
              </a:defRPr>
            </a:lvl4pPr>
            <a:lvl5pPr>
              <a:defRPr>
                <a:latin typeface="Helvetica" pitchFamily="2" charset="0"/>
              </a:defRPr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327CDC7-9740-B040-983D-33DDDDE708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Helvetica" pitchFamily="2" charset="0"/>
              </a:defRPr>
            </a:lvl1pPr>
          </a:lstStyle>
          <a:p>
            <a:fld id="{340408B7-D42E-4C40-89A4-53776FE370DD}" type="datetime1">
              <a:rPr lang="en-US" smtClean="0"/>
              <a:t>8/2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40FD91A-E71C-1D47-94FA-1050977320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Helvetica" pitchFamily="2" charset="0"/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C7963D9-D362-084E-A363-1035C73F6B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Helvetica" pitchFamily="2" charset="0"/>
              </a:defRPr>
            </a:lvl1pPr>
          </a:lstStyle>
          <a:p>
            <a:fld id="{CE44A9E8-6FDC-F24D-B37B-1656C98EFDF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10555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4406A6-B130-8646-91CA-51BA70943D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061801" y="4374479"/>
            <a:ext cx="13422452" cy="7298912"/>
          </a:xfrm>
        </p:spPr>
        <p:txBody>
          <a:bodyPr anchor="b"/>
          <a:lstStyle>
            <a:lvl1pPr>
              <a:defRPr sz="7018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A107092-8299-0F4C-96A4-1F50B49D682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1061801" y="11742440"/>
            <a:ext cx="13422452" cy="3838326"/>
          </a:xfrm>
        </p:spPr>
        <p:txBody>
          <a:bodyPr/>
          <a:lstStyle>
            <a:lvl1pPr marL="0" indent="0">
              <a:buNone/>
              <a:defRPr sz="2808">
                <a:solidFill>
                  <a:schemeClr val="tx1">
                    <a:tint val="75000"/>
                  </a:schemeClr>
                </a:solidFill>
              </a:defRPr>
            </a:lvl1pPr>
            <a:lvl2pPr marL="534800" indent="0">
              <a:buNone/>
              <a:defRPr sz="2339">
                <a:solidFill>
                  <a:schemeClr val="tx1">
                    <a:tint val="75000"/>
                  </a:schemeClr>
                </a:solidFill>
              </a:defRPr>
            </a:lvl2pPr>
            <a:lvl3pPr marL="1069601" indent="0">
              <a:buNone/>
              <a:defRPr sz="2105">
                <a:solidFill>
                  <a:schemeClr val="tx1">
                    <a:tint val="75000"/>
                  </a:schemeClr>
                </a:solidFill>
              </a:defRPr>
            </a:lvl3pPr>
            <a:lvl4pPr marL="1604400" indent="0">
              <a:buNone/>
              <a:defRPr sz="1871">
                <a:solidFill>
                  <a:schemeClr val="tx1">
                    <a:tint val="75000"/>
                  </a:schemeClr>
                </a:solidFill>
              </a:defRPr>
            </a:lvl4pPr>
            <a:lvl5pPr marL="2139200" indent="0">
              <a:buNone/>
              <a:defRPr sz="1871">
                <a:solidFill>
                  <a:schemeClr val="tx1">
                    <a:tint val="75000"/>
                  </a:schemeClr>
                </a:solidFill>
              </a:defRPr>
            </a:lvl5pPr>
            <a:lvl6pPr marL="2674001" indent="0">
              <a:buNone/>
              <a:defRPr sz="1871">
                <a:solidFill>
                  <a:schemeClr val="tx1">
                    <a:tint val="75000"/>
                  </a:schemeClr>
                </a:solidFill>
              </a:defRPr>
            </a:lvl6pPr>
            <a:lvl7pPr marL="3208801" indent="0">
              <a:buNone/>
              <a:defRPr sz="1871">
                <a:solidFill>
                  <a:schemeClr val="tx1">
                    <a:tint val="75000"/>
                  </a:schemeClr>
                </a:solidFill>
              </a:defRPr>
            </a:lvl7pPr>
            <a:lvl8pPr marL="3743601" indent="0">
              <a:buNone/>
              <a:defRPr sz="1871">
                <a:solidFill>
                  <a:schemeClr val="tx1">
                    <a:tint val="75000"/>
                  </a:schemeClr>
                </a:solidFill>
              </a:defRPr>
            </a:lvl8pPr>
            <a:lvl9pPr marL="4278401" indent="0">
              <a:buNone/>
              <a:defRPr sz="187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AD234A5-3EA3-114F-9B8B-EB41ACD3C6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5F1EB0-11AC-F446-8CA5-7341363638BD}" type="datetime1">
              <a:rPr lang="en-US" smtClean="0"/>
              <a:t>8/2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F7FDE48-88CC-6844-9818-67B67F5D15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E82AAED-26E7-0944-8097-920E2AE2A4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4A9E8-6FDC-F24D-B37B-1656C98EFD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62819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6E0AA4-ECB6-C649-A5FD-599CA1B4BE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2737DD4-21E9-A04D-8AAA-6FF372C4F1B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1069908" y="3743284"/>
            <a:ext cx="6613962" cy="1206087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DAE2B60-9163-5C47-B9BE-BB764836CD9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7878397" y="3743284"/>
            <a:ext cx="6613962" cy="1206087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21A7DC1-0841-544D-8B31-7BAE4AD41C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B1080E-0CB5-2941-B48B-86F18F07B5FA}" type="datetime1">
              <a:rPr lang="en-US" smtClean="0"/>
              <a:t>8/20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24660F6-B518-6B45-868E-407C95D4D8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78DDEB9-06EA-3740-BB27-3320884BE1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4A9E8-6FDC-F24D-B37B-1656C98EFD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21891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6F03E9-9489-B344-96BA-70C2254DB1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071932" y="934198"/>
            <a:ext cx="13422452" cy="3391538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8ED0287-7AFF-A84D-916C-B7822B3E608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1071933" y="4301366"/>
            <a:ext cx="6583566" cy="2108032"/>
          </a:xfrm>
        </p:spPr>
        <p:txBody>
          <a:bodyPr anchor="b"/>
          <a:lstStyle>
            <a:lvl1pPr marL="0" indent="0">
              <a:buNone/>
              <a:defRPr sz="2808" b="1"/>
            </a:lvl1pPr>
            <a:lvl2pPr marL="534800" indent="0">
              <a:buNone/>
              <a:defRPr sz="2339" b="1"/>
            </a:lvl2pPr>
            <a:lvl3pPr marL="1069601" indent="0">
              <a:buNone/>
              <a:defRPr sz="2105" b="1"/>
            </a:lvl3pPr>
            <a:lvl4pPr marL="1604400" indent="0">
              <a:buNone/>
              <a:defRPr sz="1871" b="1"/>
            </a:lvl4pPr>
            <a:lvl5pPr marL="2139200" indent="0">
              <a:buNone/>
              <a:defRPr sz="1871" b="1"/>
            </a:lvl5pPr>
            <a:lvl6pPr marL="2674001" indent="0">
              <a:buNone/>
              <a:defRPr sz="1871" b="1"/>
            </a:lvl6pPr>
            <a:lvl7pPr marL="3208801" indent="0">
              <a:buNone/>
              <a:defRPr sz="1871" b="1"/>
            </a:lvl7pPr>
            <a:lvl8pPr marL="3743601" indent="0">
              <a:buNone/>
              <a:defRPr sz="1871" b="1"/>
            </a:lvl8pPr>
            <a:lvl9pPr marL="4278401" indent="0">
              <a:buNone/>
              <a:defRPr sz="1871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B586489-A7CB-EE4F-8D4A-9A4C48846A2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1071933" y="6409396"/>
            <a:ext cx="6583566" cy="942725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6F99574-E31E-EF42-916F-6A9CC901AE7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7878398" y="4301366"/>
            <a:ext cx="6615989" cy="2108032"/>
          </a:xfrm>
        </p:spPr>
        <p:txBody>
          <a:bodyPr anchor="b"/>
          <a:lstStyle>
            <a:lvl1pPr marL="0" indent="0">
              <a:buNone/>
              <a:defRPr sz="2808" b="1"/>
            </a:lvl1pPr>
            <a:lvl2pPr marL="534800" indent="0">
              <a:buNone/>
              <a:defRPr sz="2339" b="1"/>
            </a:lvl2pPr>
            <a:lvl3pPr marL="1069601" indent="0">
              <a:buNone/>
              <a:defRPr sz="2105" b="1"/>
            </a:lvl3pPr>
            <a:lvl4pPr marL="1604400" indent="0">
              <a:buNone/>
              <a:defRPr sz="1871" b="1"/>
            </a:lvl4pPr>
            <a:lvl5pPr marL="2139200" indent="0">
              <a:buNone/>
              <a:defRPr sz="1871" b="1"/>
            </a:lvl5pPr>
            <a:lvl6pPr marL="2674001" indent="0">
              <a:buNone/>
              <a:defRPr sz="1871" b="1"/>
            </a:lvl6pPr>
            <a:lvl7pPr marL="3208801" indent="0">
              <a:buNone/>
              <a:defRPr sz="1871" b="1"/>
            </a:lvl7pPr>
            <a:lvl8pPr marL="3743601" indent="0">
              <a:buNone/>
              <a:defRPr sz="1871" b="1"/>
            </a:lvl8pPr>
            <a:lvl9pPr marL="4278401" indent="0">
              <a:buNone/>
              <a:defRPr sz="1871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D353DB1-1C23-404C-9DE8-78219D7C787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7878398" y="6409396"/>
            <a:ext cx="6615989" cy="942725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BB1BB78-2A66-9D4F-BFBB-BB7E1C9A5F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55C91F-C901-C74E-B457-F7DD6456F136}" type="datetime1">
              <a:rPr lang="en-US" smtClean="0"/>
              <a:t>8/20/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8FFCAAF-9320-C347-9837-DA18EAECCE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693220E-C952-9842-ADE8-3451593D17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4A9E8-6FDC-F24D-B37B-1656C98EFD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03235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8BD052-973D-994F-AF52-2A4EF5FBDE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5FF58DD-8363-6A46-9A18-1A3A67A027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79D0AC-686B-8B49-B366-3C844C4036EB}" type="datetime1">
              <a:rPr lang="en-US" smtClean="0"/>
              <a:t>8/20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98FEACB-F9AE-8C44-97F6-7880243121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A56A4EF-28C8-B843-B0C9-3D10255B93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4A9E8-6FDC-F24D-B37B-1656C98EFD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98900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E3EE6B9-1BFB-B447-ADE2-74BAB0E6F8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5D6573-C21F-0840-BAEF-1FF2575D4505}" type="datetime1">
              <a:rPr lang="en-US" smtClean="0"/>
              <a:t>8/20/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1C450CF-5F7E-5045-8B0A-4C0434E627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6094176-5BE4-AD43-A449-C8199EE33F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4A9E8-6FDC-F24D-B37B-1656C98EFD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42989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1C1379-D019-6643-B88B-FB65AC5F92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071935" y="1169776"/>
            <a:ext cx="5019235" cy="4094216"/>
          </a:xfrm>
        </p:spPr>
        <p:txBody>
          <a:bodyPr anchor="b"/>
          <a:lstStyle>
            <a:lvl1pPr>
              <a:defRPr sz="3743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158BD4D-DDCA-534A-8E83-F635DBDD4E9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615990" y="2526393"/>
            <a:ext cx="7878396" cy="12469487"/>
          </a:xfrm>
        </p:spPr>
        <p:txBody>
          <a:bodyPr/>
          <a:lstStyle>
            <a:lvl1pPr>
              <a:defRPr sz="3743"/>
            </a:lvl1pPr>
            <a:lvl2pPr>
              <a:defRPr sz="3275"/>
            </a:lvl2pPr>
            <a:lvl3pPr>
              <a:defRPr sz="2808"/>
            </a:lvl3pPr>
            <a:lvl4pPr>
              <a:defRPr sz="2339"/>
            </a:lvl4pPr>
            <a:lvl5pPr>
              <a:defRPr sz="2339"/>
            </a:lvl5pPr>
            <a:lvl6pPr>
              <a:defRPr sz="2339"/>
            </a:lvl6pPr>
            <a:lvl7pPr>
              <a:defRPr sz="2339"/>
            </a:lvl7pPr>
            <a:lvl8pPr>
              <a:defRPr sz="2339"/>
            </a:lvl8pPr>
            <a:lvl9pPr>
              <a:defRPr sz="2339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442C9D0-AF82-204E-8201-19343DD61DA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1071935" y="5263995"/>
            <a:ext cx="5019235" cy="9752194"/>
          </a:xfrm>
        </p:spPr>
        <p:txBody>
          <a:bodyPr/>
          <a:lstStyle>
            <a:lvl1pPr marL="0" indent="0">
              <a:buNone/>
              <a:defRPr sz="1871"/>
            </a:lvl1pPr>
            <a:lvl2pPr marL="534800" indent="0">
              <a:buNone/>
              <a:defRPr sz="1638"/>
            </a:lvl2pPr>
            <a:lvl3pPr marL="1069601" indent="0">
              <a:buNone/>
              <a:defRPr sz="1404"/>
            </a:lvl3pPr>
            <a:lvl4pPr marL="1604400" indent="0">
              <a:buNone/>
              <a:defRPr sz="1170"/>
            </a:lvl4pPr>
            <a:lvl5pPr marL="2139200" indent="0">
              <a:buNone/>
              <a:defRPr sz="1170"/>
            </a:lvl5pPr>
            <a:lvl6pPr marL="2674001" indent="0">
              <a:buNone/>
              <a:defRPr sz="1170"/>
            </a:lvl6pPr>
            <a:lvl7pPr marL="3208801" indent="0">
              <a:buNone/>
              <a:defRPr sz="1170"/>
            </a:lvl7pPr>
            <a:lvl8pPr marL="3743601" indent="0">
              <a:buNone/>
              <a:defRPr sz="1170"/>
            </a:lvl8pPr>
            <a:lvl9pPr marL="4278401" indent="0">
              <a:buNone/>
              <a:defRPr sz="117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B5368A2-7186-E749-BB60-CB45376A4D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D7268-FD7C-C042-A400-6B8C34629FE6}" type="datetime1">
              <a:rPr lang="en-US" smtClean="0"/>
              <a:t>8/20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729BA04-E120-A946-B561-D46CCA017B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0CC79DB-2B92-7742-9F5E-538E7EE6CD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4A9E8-6FDC-F24D-B37B-1656C98EFD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12977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F1C82B-7C1B-8F43-8CBD-0D90B839A3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071935" y="1169776"/>
            <a:ext cx="5019235" cy="4094216"/>
          </a:xfrm>
        </p:spPr>
        <p:txBody>
          <a:bodyPr anchor="b"/>
          <a:lstStyle>
            <a:lvl1pPr>
              <a:defRPr sz="3743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D15C3E0-9E53-C34D-8BE5-403FD644086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6615990" y="2526393"/>
            <a:ext cx="7878396" cy="12469487"/>
          </a:xfrm>
        </p:spPr>
        <p:txBody>
          <a:bodyPr/>
          <a:lstStyle>
            <a:lvl1pPr marL="0" indent="0">
              <a:buNone/>
              <a:defRPr sz="3743"/>
            </a:lvl1pPr>
            <a:lvl2pPr marL="534800" indent="0">
              <a:buNone/>
              <a:defRPr sz="3275"/>
            </a:lvl2pPr>
            <a:lvl3pPr marL="1069601" indent="0">
              <a:buNone/>
              <a:defRPr sz="2808"/>
            </a:lvl3pPr>
            <a:lvl4pPr marL="1604400" indent="0">
              <a:buNone/>
              <a:defRPr sz="2339"/>
            </a:lvl4pPr>
            <a:lvl5pPr marL="2139200" indent="0">
              <a:buNone/>
              <a:defRPr sz="2339"/>
            </a:lvl5pPr>
            <a:lvl6pPr marL="2674001" indent="0">
              <a:buNone/>
              <a:defRPr sz="2339"/>
            </a:lvl6pPr>
            <a:lvl7pPr marL="3208801" indent="0">
              <a:buNone/>
              <a:defRPr sz="2339"/>
            </a:lvl7pPr>
            <a:lvl8pPr marL="3743601" indent="0">
              <a:buNone/>
              <a:defRPr sz="2339"/>
            </a:lvl8pPr>
            <a:lvl9pPr marL="4278401" indent="0">
              <a:buNone/>
              <a:defRPr sz="2339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B4C6D1B-B939-084A-AA38-F2265164BA0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1071935" y="5263995"/>
            <a:ext cx="5019235" cy="9752194"/>
          </a:xfrm>
        </p:spPr>
        <p:txBody>
          <a:bodyPr/>
          <a:lstStyle>
            <a:lvl1pPr marL="0" indent="0">
              <a:buNone/>
              <a:defRPr sz="1871"/>
            </a:lvl1pPr>
            <a:lvl2pPr marL="534800" indent="0">
              <a:buNone/>
              <a:defRPr sz="1638"/>
            </a:lvl2pPr>
            <a:lvl3pPr marL="1069601" indent="0">
              <a:buNone/>
              <a:defRPr sz="1404"/>
            </a:lvl3pPr>
            <a:lvl4pPr marL="1604400" indent="0">
              <a:buNone/>
              <a:defRPr sz="1170"/>
            </a:lvl4pPr>
            <a:lvl5pPr marL="2139200" indent="0">
              <a:buNone/>
              <a:defRPr sz="1170"/>
            </a:lvl5pPr>
            <a:lvl6pPr marL="2674001" indent="0">
              <a:buNone/>
              <a:defRPr sz="1170"/>
            </a:lvl6pPr>
            <a:lvl7pPr marL="3208801" indent="0">
              <a:buNone/>
              <a:defRPr sz="1170"/>
            </a:lvl7pPr>
            <a:lvl8pPr marL="3743601" indent="0">
              <a:buNone/>
              <a:defRPr sz="1170"/>
            </a:lvl8pPr>
            <a:lvl9pPr marL="4278401" indent="0">
              <a:buNone/>
              <a:defRPr sz="117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395EC78-0900-3A42-A704-5CF19E63CC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69D5A2-F22A-5741-B25B-A3DF52EE1886}" type="datetime1">
              <a:rPr lang="en-US" smtClean="0"/>
              <a:t>8/20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31E44BA-DA4D-FB45-BD8D-5126D010EA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DFA10B7-6203-F24D-9E0C-733A6B0C23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4A9E8-6FDC-F24D-B37B-1656C98EFD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11049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A985200-F03E-DA4D-914D-EBD5272FAD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069906" y="934198"/>
            <a:ext cx="13422452" cy="280908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B27D6C5-F073-1E46-B343-DB812445F37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1069906" y="3743282"/>
            <a:ext cx="13422452" cy="12072087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04EB330-0B14-4A48-890E-1E183994724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1069908" y="16263137"/>
            <a:ext cx="3501510" cy="93419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404">
                <a:solidFill>
                  <a:schemeClr val="tx1">
                    <a:tint val="75000"/>
                  </a:schemeClr>
                </a:solidFill>
                <a:latin typeface="Helvetica" pitchFamily="2" charset="0"/>
                <a:cs typeface="Arial" panose="020B0604020202020204" pitchFamily="34" charset="0"/>
              </a:defRPr>
            </a:lvl1pPr>
          </a:lstStyle>
          <a:p>
            <a:fld id="{232FD189-7F13-AC44-ADD0-90F8923151ED}" type="datetime1">
              <a:rPr lang="en-US" smtClean="0"/>
              <a:t>8/2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FF21E18-00F1-0145-899C-ECF615AEA97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5155000" y="16263137"/>
            <a:ext cx="5252264" cy="93419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404">
                <a:solidFill>
                  <a:schemeClr val="tx1">
                    <a:tint val="75000"/>
                  </a:schemeClr>
                </a:solidFill>
                <a:latin typeface="Helvetica" pitchFamily="2" charset="0"/>
                <a:cs typeface="Arial" panose="020B0604020202020204" pitchFamily="34" charset="0"/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47FFE07-FCDD-3549-9A82-C340CF9F90A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10990849" y="16263137"/>
            <a:ext cx="3501510" cy="93419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404">
                <a:solidFill>
                  <a:schemeClr val="tx1">
                    <a:tint val="75000"/>
                  </a:schemeClr>
                </a:solidFill>
                <a:latin typeface="Helvetica" pitchFamily="2" charset="0"/>
                <a:cs typeface="Arial" panose="020B0604020202020204" pitchFamily="34" charset="0"/>
              </a:defRPr>
            </a:lvl1pPr>
          </a:lstStyle>
          <a:p>
            <a:fld id="{CE44A9E8-6FDC-F24D-B37B-1656C98EFDF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39725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l" defTabSz="1069601" rtl="0" eaLnBrk="1" latinLnBrk="0" hangingPunct="1">
        <a:lnSpc>
          <a:spcPct val="90000"/>
        </a:lnSpc>
        <a:spcBef>
          <a:spcPct val="0"/>
        </a:spcBef>
        <a:buNone/>
        <a:defRPr sz="3275" kern="1200">
          <a:solidFill>
            <a:schemeClr val="tx1"/>
          </a:solidFill>
          <a:latin typeface="Helvetica" pitchFamily="2" charset="0"/>
          <a:ea typeface="+mj-ea"/>
          <a:cs typeface="Arial" panose="020B0604020202020204" pitchFamily="34" charset="0"/>
        </a:defRPr>
      </a:lvl1pPr>
    </p:titleStyle>
    <p:bodyStyle>
      <a:lvl1pPr marL="267400" indent="-267400" algn="l" defTabSz="1069601" rtl="0" eaLnBrk="1" latinLnBrk="0" hangingPunct="1">
        <a:lnSpc>
          <a:spcPct val="90000"/>
        </a:lnSpc>
        <a:spcBef>
          <a:spcPts val="1170"/>
        </a:spcBef>
        <a:buFont typeface="Arial" panose="020B0604020202020204" pitchFamily="34" charset="0"/>
        <a:buChar char="•"/>
        <a:defRPr sz="2339" kern="1200">
          <a:solidFill>
            <a:schemeClr val="tx1"/>
          </a:solidFill>
          <a:latin typeface="Helvetica" pitchFamily="2" charset="0"/>
          <a:ea typeface="+mn-ea"/>
          <a:cs typeface="Arial" panose="020B0604020202020204" pitchFamily="34" charset="0"/>
        </a:defRPr>
      </a:lvl1pPr>
      <a:lvl2pPr marL="802200" indent="-267400" algn="l" defTabSz="1069601" rtl="0" eaLnBrk="1" latinLnBrk="0" hangingPunct="1">
        <a:lnSpc>
          <a:spcPct val="90000"/>
        </a:lnSpc>
        <a:spcBef>
          <a:spcPts val="585"/>
        </a:spcBef>
        <a:buFont typeface="Arial" panose="020B0604020202020204" pitchFamily="34" charset="0"/>
        <a:buChar char="•"/>
        <a:defRPr sz="2105" kern="1200">
          <a:solidFill>
            <a:schemeClr val="tx1"/>
          </a:solidFill>
          <a:latin typeface="Helvetica" pitchFamily="2" charset="0"/>
          <a:ea typeface="+mn-ea"/>
          <a:cs typeface="Arial" panose="020B0604020202020204" pitchFamily="34" charset="0"/>
        </a:defRPr>
      </a:lvl2pPr>
      <a:lvl3pPr marL="1337000" indent="-267400" algn="l" defTabSz="1069601" rtl="0" eaLnBrk="1" latinLnBrk="0" hangingPunct="1">
        <a:lnSpc>
          <a:spcPct val="90000"/>
        </a:lnSpc>
        <a:spcBef>
          <a:spcPts val="585"/>
        </a:spcBef>
        <a:buFont typeface="Arial" panose="020B0604020202020204" pitchFamily="34" charset="0"/>
        <a:buChar char="•"/>
        <a:defRPr sz="1871" kern="1200">
          <a:solidFill>
            <a:schemeClr val="tx1"/>
          </a:solidFill>
          <a:latin typeface="Helvetica" pitchFamily="2" charset="0"/>
          <a:ea typeface="+mn-ea"/>
          <a:cs typeface="Arial" panose="020B0604020202020204" pitchFamily="34" charset="0"/>
        </a:defRPr>
      </a:lvl3pPr>
      <a:lvl4pPr marL="1871801" indent="-267400" algn="l" defTabSz="1069601" rtl="0" eaLnBrk="1" latinLnBrk="0" hangingPunct="1">
        <a:lnSpc>
          <a:spcPct val="90000"/>
        </a:lnSpc>
        <a:spcBef>
          <a:spcPts val="585"/>
        </a:spcBef>
        <a:buFont typeface="Arial" panose="020B0604020202020204" pitchFamily="34" charset="0"/>
        <a:buChar char="•"/>
        <a:defRPr sz="1638" kern="1200">
          <a:solidFill>
            <a:schemeClr val="tx1"/>
          </a:solidFill>
          <a:latin typeface="Helvetica" pitchFamily="2" charset="0"/>
          <a:ea typeface="+mn-ea"/>
          <a:cs typeface="Arial" panose="020B0604020202020204" pitchFamily="34" charset="0"/>
        </a:defRPr>
      </a:lvl4pPr>
      <a:lvl5pPr marL="2406601" indent="-267400" algn="l" defTabSz="1069601" rtl="0" eaLnBrk="1" latinLnBrk="0" hangingPunct="1">
        <a:lnSpc>
          <a:spcPct val="90000"/>
        </a:lnSpc>
        <a:spcBef>
          <a:spcPts val="585"/>
        </a:spcBef>
        <a:buFont typeface="Arial" panose="020B0604020202020204" pitchFamily="34" charset="0"/>
        <a:buChar char="•"/>
        <a:defRPr sz="1404" kern="1200">
          <a:solidFill>
            <a:schemeClr val="tx1"/>
          </a:solidFill>
          <a:latin typeface="Helvetica" pitchFamily="2" charset="0"/>
          <a:ea typeface="+mn-ea"/>
          <a:cs typeface="Arial" panose="020B0604020202020204" pitchFamily="34" charset="0"/>
        </a:defRPr>
      </a:lvl5pPr>
      <a:lvl6pPr marL="2941400" indent="-267400" algn="l" defTabSz="1069601" rtl="0" eaLnBrk="1" latinLnBrk="0" hangingPunct="1">
        <a:lnSpc>
          <a:spcPct val="90000"/>
        </a:lnSpc>
        <a:spcBef>
          <a:spcPts val="585"/>
        </a:spcBef>
        <a:buFont typeface="Arial" panose="020B0604020202020204" pitchFamily="34" charset="0"/>
        <a:buChar char="•"/>
        <a:defRPr sz="2105" kern="1200">
          <a:solidFill>
            <a:schemeClr val="tx1"/>
          </a:solidFill>
          <a:latin typeface="+mn-lt"/>
          <a:ea typeface="+mn-ea"/>
          <a:cs typeface="+mn-cs"/>
        </a:defRPr>
      </a:lvl6pPr>
      <a:lvl7pPr marL="3476201" indent="-267400" algn="l" defTabSz="1069601" rtl="0" eaLnBrk="1" latinLnBrk="0" hangingPunct="1">
        <a:lnSpc>
          <a:spcPct val="90000"/>
        </a:lnSpc>
        <a:spcBef>
          <a:spcPts val="585"/>
        </a:spcBef>
        <a:buFont typeface="Arial" panose="020B0604020202020204" pitchFamily="34" charset="0"/>
        <a:buChar char="•"/>
        <a:defRPr sz="2105" kern="1200">
          <a:solidFill>
            <a:schemeClr val="tx1"/>
          </a:solidFill>
          <a:latin typeface="+mn-lt"/>
          <a:ea typeface="+mn-ea"/>
          <a:cs typeface="+mn-cs"/>
        </a:defRPr>
      </a:lvl7pPr>
      <a:lvl8pPr marL="4011001" indent="-267400" algn="l" defTabSz="1069601" rtl="0" eaLnBrk="1" latinLnBrk="0" hangingPunct="1">
        <a:lnSpc>
          <a:spcPct val="90000"/>
        </a:lnSpc>
        <a:spcBef>
          <a:spcPts val="585"/>
        </a:spcBef>
        <a:buFont typeface="Arial" panose="020B0604020202020204" pitchFamily="34" charset="0"/>
        <a:buChar char="•"/>
        <a:defRPr sz="2105" kern="1200">
          <a:solidFill>
            <a:schemeClr val="tx1"/>
          </a:solidFill>
          <a:latin typeface="+mn-lt"/>
          <a:ea typeface="+mn-ea"/>
          <a:cs typeface="+mn-cs"/>
        </a:defRPr>
      </a:lvl8pPr>
      <a:lvl9pPr marL="4545801" indent="-267400" algn="l" defTabSz="1069601" rtl="0" eaLnBrk="1" latinLnBrk="0" hangingPunct="1">
        <a:lnSpc>
          <a:spcPct val="90000"/>
        </a:lnSpc>
        <a:spcBef>
          <a:spcPts val="585"/>
        </a:spcBef>
        <a:buFont typeface="Arial" panose="020B0604020202020204" pitchFamily="34" charset="0"/>
        <a:buChar char="•"/>
        <a:defRPr sz="210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69601" rtl="0" eaLnBrk="1" latinLnBrk="0" hangingPunct="1">
        <a:defRPr sz="2105" kern="1200">
          <a:solidFill>
            <a:schemeClr val="tx1"/>
          </a:solidFill>
          <a:latin typeface="+mn-lt"/>
          <a:ea typeface="+mn-ea"/>
          <a:cs typeface="+mn-cs"/>
        </a:defRPr>
      </a:lvl1pPr>
      <a:lvl2pPr marL="534800" algn="l" defTabSz="1069601" rtl="0" eaLnBrk="1" latinLnBrk="0" hangingPunct="1">
        <a:defRPr sz="2105" kern="1200">
          <a:solidFill>
            <a:schemeClr val="tx1"/>
          </a:solidFill>
          <a:latin typeface="+mn-lt"/>
          <a:ea typeface="+mn-ea"/>
          <a:cs typeface="+mn-cs"/>
        </a:defRPr>
      </a:lvl2pPr>
      <a:lvl3pPr marL="1069601" algn="l" defTabSz="1069601" rtl="0" eaLnBrk="1" latinLnBrk="0" hangingPunct="1">
        <a:defRPr sz="2105" kern="1200">
          <a:solidFill>
            <a:schemeClr val="tx1"/>
          </a:solidFill>
          <a:latin typeface="+mn-lt"/>
          <a:ea typeface="+mn-ea"/>
          <a:cs typeface="+mn-cs"/>
        </a:defRPr>
      </a:lvl3pPr>
      <a:lvl4pPr marL="1604400" algn="l" defTabSz="1069601" rtl="0" eaLnBrk="1" latinLnBrk="0" hangingPunct="1">
        <a:defRPr sz="2105" kern="1200">
          <a:solidFill>
            <a:schemeClr val="tx1"/>
          </a:solidFill>
          <a:latin typeface="+mn-lt"/>
          <a:ea typeface="+mn-ea"/>
          <a:cs typeface="+mn-cs"/>
        </a:defRPr>
      </a:lvl4pPr>
      <a:lvl5pPr marL="2139200" algn="l" defTabSz="1069601" rtl="0" eaLnBrk="1" latinLnBrk="0" hangingPunct="1">
        <a:defRPr sz="2105" kern="1200">
          <a:solidFill>
            <a:schemeClr val="tx1"/>
          </a:solidFill>
          <a:latin typeface="+mn-lt"/>
          <a:ea typeface="+mn-ea"/>
          <a:cs typeface="+mn-cs"/>
        </a:defRPr>
      </a:lvl5pPr>
      <a:lvl6pPr marL="2674001" algn="l" defTabSz="1069601" rtl="0" eaLnBrk="1" latinLnBrk="0" hangingPunct="1">
        <a:defRPr sz="2105" kern="1200">
          <a:solidFill>
            <a:schemeClr val="tx1"/>
          </a:solidFill>
          <a:latin typeface="+mn-lt"/>
          <a:ea typeface="+mn-ea"/>
          <a:cs typeface="+mn-cs"/>
        </a:defRPr>
      </a:lvl6pPr>
      <a:lvl7pPr marL="3208801" algn="l" defTabSz="1069601" rtl="0" eaLnBrk="1" latinLnBrk="0" hangingPunct="1">
        <a:defRPr sz="2105" kern="1200">
          <a:solidFill>
            <a:schemeClr val="tx1"/>
          </a:solidFill>
          <a:latin typeface="+mn-lt"/>
          <a:ea typeface="+mn-ea"/>
          <a:cs typeface="+mn-cs"/>
        </a:defRPr>
      </a:lvl7pPr>
      <a:lvl8pPr marL="3743601" algn="l" defTabSz="1069601" rtl="0" eaLnBrk="1" latinLnBrk="0" hangingPunct="1">
        <a:defRPr sz="2105" kern="1200">
          <a:solidFill>
            <a:schemeClr val="tx1"/>
          </a:solidFill>
          <a:latin typeface="+mn-lt"/>
          <a:ea typeface="+mn-ea"/>
          <a:cs typeface="+mn-cs"/>
        </a:defRPr>
      </a:lvl8pPr>
      <a:lvl9pPr marL="4278401" algn="l" defTabSz="1069601" rtl="0" eaLnBrk="1" latinLnBrk="0" hangingPunct="1">
        <a:defRPr sz="210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>
            <a:extLst>
              <a:ext uri="{FF2B5EF4-FFF2-40B4-BE49-F238E27FC236}">
                <a16:creationId xmlns:a16="http://schemas.microsoft.com/office/drawing/2014/main" id="{811DEEC3-A131-72BA-2EE1-16EB94A33AE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309882" y="738076"/>
            <a:ext cx="3822700" cy="7112000"/>
          </a:xfrm>
          <a:prstGeom prst="rect">
            <a:avLst/>
          </a:prstGeom>
        </p:spPr>
      </p:pic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C5F74B3-D458-EBB5-9A47-4958F4FE6F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4A9E8-6FDC-F24D-B37B-1656C98EFDFD}" type="slidenum">
              <a:rPr lang="en-US" smtClean="0"/>
              <a:pPr/>
              <a:t>1</a:t>
            </a:fld>
            <a:endParaRPr lang="en-US"/>
          </a:p>
        </p:txBody>
      </p:sp>
      <p:sp>
        <p:nvSpPr>
          <p:cNvPr id="19" name="TextBox 2">
            <a:extLst>
              <a:ext uri="{FF2B5EF4-FFF2-40B4-BE49-F238E27FC236}">
                <a16:creationId xmlns:a16="http://schemas.microsoft.com/office/drawing/2014/main" id="{2B5FF00E-CDF7-2633-03CB-A33FBE093D61}"/>
              </a:ext>
            </a:extLst>
          </p:cNvPr>
          <p:cNvSpPr txBox="1"/>
          <p:nvPr/>
        </p:nvSpPr>
        <p:spPr>
          <a:xfrm>
            <a:off x="353439" y="662912"/>
            <a:ext cx="43473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57190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14379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71569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228759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785948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3343138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900327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4457517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15259A06-E51D-F074-9C21-F0C88B678F0F}"/>
              </a:ext>
            </a:extLst>
          </p:cNvPr>
          <p:cNvSpPr txBox="1"/>
          <p:nvPr/>
        </p:nvSpPr>
        <p:spPr>
          <a:xfrm>
            <a:off x="654987" y="8306221"/>
            <a:ext cx="13825119" cy="9341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3. Baseline secretory profile of macrophages and fibroblasts</a:t>
            </a: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A-B) LEGENDplex analysis of Immune response (A)  and TNF family (B) proteins for 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MR90 fibroblasts cell line and</a:t>
            </a:r>
            <a:r>
              <a:rPr lang="en-US" sz="18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BMC-derived M0, M1 and M2 macrophages immediately following polarization, total concentrations (</a:t>
            </a:r>
            <a:r>
              <a:rPr lang="en-US" sz="1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g</a:t>
            </a: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mL).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BE0C0C76-EA4F-2963-FDD6-57A7AD6B7320}"/>
              </a:ext>
            </a:extLst>
          </p:cNvPr>
          <p:cNvSpPr txBox="1"/>
          <p:nvPr/>
        </p:nvSpPr>
        <p:spPr>
          <a:xfrm>
            <a:off x="2178758" y="324249"/>
            <a:ext cx="2295314" cy="415886"/>
          </a:xfrm>
          <a:prstGeom prst="rect">
            <a:avLst/>
          </a:prstGeom>
          <a:solidFill>
            <a:schemeClr val="bg1"/>
          </a:solidFill>
        </p:spPr>
        <p:txBody>
          <a:bodyPr wrap="none" lIns="107064" tIns="53532" rIns="107064" bIns="53532" rtlCol="0" anchor="t">
            <a:spAutoFit/>
          </a:bodyPr>
          <a:lstStyle/>
          <a:p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mmune Response 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B43F2F8-D915-8158-1554-2A95FC47A2DF}"/>
              </a:ext>
            </a:extLst>
          </p:cNvPr>
          <p:cNvSpPr txBox="1"/>
          <p:nvPr/>
        </p:nvSpPr>
        <p:spPr>
          <a:xfrm>
            <a:off x="7288104" y="324249"/>
            <a:ext cx="1511445" cy="415886"/>
          </a:xfrm>
          <a:prstGeom prst="rect">
            <a:avLst/>
          </a:prstGeom>
          <a:solidFill>
            <a:schemeClr val="bg1"/>
          </a:solidFill>
        </p:spPr>
        <p:txBody>
          <a:bodyPr wrap="none" lIns="107064" tIns="53532" rIns="107064" bIns="53532" rtlCol="0" anchor="t">
            <a:spAutoFit/>
          </a:bodyPr>
          <a:lstStyle/>
          <a:p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NF-family</a:t>
            </a:r>
          </a:p>
        </p:txBody>
      </p:sp>
      <p:sp>
        <p:nvSpPr>
          <p:cNvPr id="6" name="TextBox 2">
            <a:extLst>
              <a:ext uri="{FF2B5EF4-FFF2-40B4-BE49-F238E27FC236}">
                <a16:creationId xmlns:a16="http://schemas.microsoft.com/office/drawing/2014/main" id="{942244AD-55E4-7120-AE3A-B01674FF2106}"/>
              </a:ext>
            </a:extLst>
          </p:cNvPr>
          <p:cNvSpPr txBox="1"/>
          <p:nvPr/>
        </p:nvSpPr>
        <p:spPr>
          <a:xfrm>
            <a:off x="6028089" y="673057"/>
            <a:ext cx="42030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57190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14379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71569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228759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785948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3343138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900327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4457517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A7A245CF-B8C5-38CF-600A-F5CFE7F5BD8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69581" y="738076"/>
            <a:ext cx="4381500" cy="711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790672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Custom 3">
      <a:dk1>
        <a:srgbClr val="000000"/>
      </a:dk1>
      <a:lt1>
        <a:srgbClr val="FFFFFF"/>
      </a:lt1>
      <a:dk2>
        <a:srgbClr val="335B74"/>
      </a:dk2>
      <a:lt2>
        <a:srgbClr val="DFE3E5"/>
      </a:lt2>
      <a:accent1>
        <a:srgbClr val="1CADE4"/>
      </a:accent1>
      <a:accent2>
        <a:srgbClr val="2683C6"/>
      </a:accent2>
      <a:accent3>
        <a:srgbClr val="27CED7"/>
      </a:accent3>
      <a:accent4>
        <a:srgbClr val="42BA97"/>
      </a:accent4>
      <a:accent5>
        <a:srgbClr val="3E8853"/>
      </a:accent5>
      <a:accent6>
        <a:srgbClr val="62A39F"/>
      </a:accent6>
      <a:hlink>
        <a:srgbClr val="6EAC1C"/>
      </a:hlink>
      <a:folHlink>
        <a:srgbClr val="B26B0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txDef>
      <a:spPr>
        <a:noFill/>
      </a:spPr>
      <a:bodyPr wrap="none" rtlCol="0">
        <a:spAutoFit/>
      </a:bodyPr>
      <a:lstStyle>
        <a:defPPr algn="l">
          <a:defRPr sz="1600" dirty="0">
            <a:latin typeface="Helvetica" pitchFamily="2" charset="0"/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name="DenayLuis_Paper layout V1" id="{E285C894-8600-BE43-9C63-6DC2C64A29EE}" vid="{C2BEA0BC-9915-6141-982A-C72D398425BF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384</TotalTime>
  <Words>62</Words>
  <Application>Microsoft Macintosh PowerPoint</Application>
  <PresentationFormat>Custom</PresentationFormat>
  <Paragraphs>7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Helvetica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ELISAs of polarized macrophage supernatants: TNF-α and IL-1β (M1)</dc:title>
  <dc:creator>Microsoft Office User</dc:creator>
  <cp:lastModifiedBy>Carrie House</cp:lastModifiedBy>
  <cp:revision>80</cp:revision>
  <dcterms:created xsi:type="dcterms:W3CDTF">2022-01-18T04:14:07Z</dcterms:created>
  <dcterms:modified xsi:type="dcterms:W3CDTF">2024-08-20T23:32:57Z</dcterms:modified>
</cp:coreProperties>
</file>